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Dailu Guan" initials="DG" lastIdx="1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18" d="100"/>
          <a:sy n="118" d="100"/>
        </p:scale>
        <p:origin x="-1482" y="22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CB78F-2471-4EB9-A7FD-C1B3AF67DAC9}" type="datetimeFigureOut">
              <a:rPr lang="en-US" smtClean="0"/>
              <a:t>1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218E5-39B1-4EAB-9789-3AA80A9B15C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38213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CB78F-2471-4EB9-A7FD-C1B3AF67DAC9}" type="datetimeFigureOut">
              <a:rPr lang="en-US" smtClean="0"/>
              <a:t>1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218E5-39B1-4EAB-9789-3AA80A9B15C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61712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CB78F-2471-4EB9-A7FD-C1B3AF67DAC9}" type="datetimeFigureOut">
              <a:rPr lang="en-US" smtClean="0"/>
              <a:t>1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218E5-39B1-4EAB-9789-3AA80A9B15C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03413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CB78F-2471-4EB9-A7FD-C1B3AF67DAC9}" type="datetimeFigureOut">
              <a:rPr lang="en-US" smtClean="0"/>
              <a:t>1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218E5-39B1-4EAB-9789-3AA80A9B15C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20301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CB78F-2471-4EB9-A7FD-C1B3AF67DAC9}" type="datetimeFigureOut">
              <a:rPr lang="en-US" smtClean="0"/>
              <a:t>1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218E5-39B1-4EAB-9789-3AA80A9B15C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42546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CB78F-2471-4EB9-A7FD-C1B3AF67DAC9}" type="datetimeFigureOut">
              <a:rPr lang="en-US" smtClean="0"/>
              <a:t>1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218E5-39B1-4EAB-9789-3AA80A9B15C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59761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CB78F-2471-4EB9-A7FD-C1B3AF67DAC9}" type="datetimeFigureOut">
              <a:rPr lang="en-US" smtClean="0"/>
              <a:t>1/14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218E5-39B1-4EAB-9789-3AA80A9B15C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8054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CB78F-2471-4EB9-A7FD-C1B3AF67DAC9}" type="datetimeFigureOut">
              <a:rPr lang="en-US" smtClean="0"/>
              <a:t>1/14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218E5-39B1-4EAB-9789-3AA80A9B15C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1790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CB78F-2471-4EB9-A7FD-C1B3AF67DAC9}" type="datetimeFigureOut">
              <a:rPr lang="en-US" smtClean="0"/>
              <a:t>1/14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218E5-39B1-4EAB-9789-3AA80A9B15C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0085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CB78F-2471-4EB9-A7FD-C1B3AF67DAC9}" type="datetimeFigureOut">
              <a:rPr lang="en-US" smtClean="0"/>
              <a:t>1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218E5-39B1-4EAB-9789-3AA80A9B15C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01382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CB78F-2471-4EB9-A7FD-C1B3AF67DAC9}" type="datetimeFigureOut">
              <a:rPr lang="en-US" smtClean="0"/>
              <a:t>1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218E5-39B1-4EAB-9789-3AA80A9B15C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55403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2CB78F-2471-4EB9-A7FD-C1B3AF67DAC9}" type="datetimeFigureOut">
              <a:rPr lang="en-US" smtClean="0"/>
              <a:t>1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0218E5-39B1-4EAB-9789-3AA80A9B15C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3541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/>
          <p:cNvGrpSpPr/>
          <p:nvPr/>
        </p:nvGrpSpPr>
        <p:grpSpPr>
          <a:xfrm>
            <a:off x="998220" y="0"/>
            <a:ext cx="6383655" cy="5429250"/>
            <a:chOff x="823107" y="290147"/>
            <a:chExt cx="6211106" cy="5457459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528" t="10278" r="2500" b="10971"/>
            <a:stretch/>
          </p:blipFill>
          <p:spPr>
            <a:xfrm>
              <a:off x="823107" y="290147"/>
              <a:ext cx="6061271" cy="5457459"/>
            </a:xfrm>
            <a:prstGeom prst="rect">
              <a:avLst/>
            </a:prstGeom>
          </p:spPr>
        </p:pic>
        <p:cxnSp>
          <p:nvCxnSpPr>
            <p:cNvPr id="5" name="Straight Arrow Connector 4"/>
            <p:cNvCxnSpPr/>
            <p:nvPr/>
          </p:nvCxnSpPr>
          <p:spPr>
            <a:xfrm flipH="1">
              <a:off x="6858185" y="3557588"/>
              <a:ext cx="176028" cy="2303"/>
            </a:xfrm>
            <a:prstGeom prst="straightConnector1">
              <a:avLst/>
            </a:prstGeom>
            <a:ln w="25400">
              <a:solidFill>
                <a:srgbClr val="FF0000"/>
              </a:solidFill>
              <a:headEnd type="none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TextBox 1"/>
          <p:cNvSpPr txBox="1"/>
          <p:nvPr/>
        </p:nvSpPr>
        <p:spPr>
          <a:xfrm>
            <a:off x="113570" y="5380672"/>
            <a:ext cx="8897814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ditional file 2: Figure S1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milarity matrix of samples used for detecting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fferentially expressed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s. T1, T2 and </a:t>
            </a:r>
            <a:r>
              <a:rPr lang="en-US" altLang="zh-CN" sz="16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3 </a:t>
            </a:r>
            <a:r>
              <a:rPr lang="en-US" altLang="zh-CN" sz="16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rrespond to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8.25 ± 9.29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s (T1, early lactation),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16.25 ± 9.29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s (T2, late lactation) and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85.25 ± 9.29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s (T3, dry period) after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rturition, respectively. The sample T3-22 (red arrow) clustered with T1/T2 samples probably because it was obtained from a goat that was not successfully dried-off at the time of sampling. 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036604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45</TotalTime>
  <Words>90</Words>
  <Application>Microsoft Office PowerPoint</Application>
  <PresentationFormat>Presentación en pantalla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Office Theme</vt:lpstr>
      <vt:lpstr>Presentación de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ilu Guan</dc:creator>
  <cp:lastModifiedBy>ma</cp:lastModifiedBy>
  <cp:revision>15</cp:revision>
  <dcterms:created xsi:type="dcterms:W3CDTF">2019-08-02T16:05:27Z</dcterms:created>
  <dcterms:modified xsi:type="dcterms:W3CDTF">2020-01-14T18:11:43Z</dcterms:modified>
</cp:coreProperties>
</file>